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5174A-C69B-4266-B9BC-23D1777DF7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F8BC13E-841A-4FB1-B254-6962266B2E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19C647-4A9B-488C-9AEB-98425D8CB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EAA342-F29B-455D-878B-1EBDB1070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2CFE31-5B09-4ACE-9D7F-EBA1A2CBA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563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C46B74-C82F-44ED-BB5C-496BC2C905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531D56-9B6B-4AE6-96AD-52D4A6DD76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E7D44A-0EC5-4E9A-82A7-2511BFD8E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AFD9AF-B823-4A7D-9478-D426CA3BD6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B72D41-DF95-4BAE-A0FA-323C1933A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077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5759149-6BAF-431F-A3C2-CF9FD871A3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FD63F8-5B4F-43E8-9F21-00B2E71AF1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841981-A659-4E16-B199-092742CD5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E1DBBC-3C23-48ED-B11B-FEEE2631F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94531D-C08B-40E1-84BF-31B8CABE6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603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CBA144-8EB9-4FDD-B8BE-859E2B5847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188BFE-0F57-4869-A02D-96B5E44064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B1B6A7-9304-4F71-A304-81D8E6B8C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DE36C0-561C-40CB-9986-FECD9A9A3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852B80-6EA9-4A2D-83AD-D8B5EC124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124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2EE5D6-D1EA-4A51-873E-278553F674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9E7E27-DA30-476A-B1F5-A2539EA976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5F5387-F9F7-45F8-A9F5-A8177F1A4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C96A1E-08A1-43FB-92DD-1DD7450F8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B0ED6F-5BE8-444E-9688-6ED776C9C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860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54F1B-629F-4258-9DDA-C190C6A8FD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E4D375-531B-4994-ABAA-217C512AA0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AE3249-B931-4C6F-A083-8874CC7A27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1B67A5-341F-4D04-91EC-6D66AE6A5E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D81E35-0020-4E8B-958D-B736AB338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CFDD7A-1716-4010-AD2E-E0E9555CEF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976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D2392F-9BE2-45B0-B56B-D14FB5E9E2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BAA15-D61E-4D02-B715-0A896B6E77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8BAD0C-1C21-4AA3-906E-8853B26519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FD6ED3C-258E-4A38-9D2D-C92306D130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A51769-B134-472C-A944-F5819D2EDF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62745A-379C-491B-A709-36D4F1E04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41FD78-953F-4D99-ACC9-B2E9B4D98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BB7BF78-3756-4DE6-BB05-12CC1112A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570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327673-16FC-49AC-82BA-5601AB1F8E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47D9847-6FBB-4C52-A1DF-9173D7AEE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28618A-549D-425C-B2CA-B64EC9CB3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450966-EC79-49C0-A6B0-844C8C903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763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93776D4-61FD-493A-9FF1-045F344AB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BC12ECC-E6DE-45AC-AC99-02982062F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6E7837-7EB0-42BE-A61B-19DA7C488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28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1A3A57-692D-4A1A-A14C-F17D6396FB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E41454-131A-4D5D-B908-74161D9B76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809005-400E-48BF-87C1-F5E9022624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ACEB12-F3E3-4753-801D-34137F5EB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ED8072-CFF6-49A7-864B-B6068FEF5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249936-EA09-4E1E-A720-C6F948895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576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741469-988F-4A7C-B8D6-6313CE23B4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65ECEF0-A58C-4FC6-A5A3-B2023FB188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930AAD-B005-4D1A-AF9B-5CD21E4B8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917EDA-20F0-415F-96F0-1CED5B071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0E7C77-4AE0-4512-8982-197235A89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D20218-A7C5-44CA-80CB-0FF26E0A1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865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FA07108-E870-4C4F-84E5-876F3445C1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BE9BAE-B545-4049-9510-B790269898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922B5-42FA-4A4B-A78E-0DF0375E4F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F73BA4-E083-4A9F-9765-15151CBCCF41}" type="datetimeFigureOut">
              <a:rPr lang="en-US" smtClean="0"/>
              <a:t>8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97A8A3-093D-4562-9BB0-1F43FD8256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806612-4D36-4240-9347-6DCF11ACED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ED315E-B0C8-46E4-85FD-B0FA1CFDB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645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00000000-0008-0000-0200-000018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4094204" cy="3398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1568745-B522-48AD-9ABB-972CF6CC5DB2}"/>
              </a:ext>
            </a:extLst>
          </p:cNvPr>
          <p:cNvSpPr txBox="1"/>
          <p:nvPr/>
        </p:nvSpPr>
        <p:spPr>
          <a:xfrm>
            <a:off x="218597" y="2861736"/>
            <a:ext cx="12274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. Congregate settings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0000000-0008-0000-0200-000019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4204" y="105485"/>
            <a:ext cx="4020065" cy="32926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A43B0FF-7BEA-42D8-BEB8-B132C1998584}"/>
              </a:ext>
            </a:extLst>
          </p:cNvPr>
          <p:cNvSpPr txBox="1"/>
          <p:nvPr/>
        </p:nvSpPr>
        <p:spPr>
          <a:xfrm>
            <a:off x="4094204" y="2905780"/>
            <a:ext cx="1227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. Hospitals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00000000-0008-0000-0200-00001A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97798" y="-1"/>
            <a:ext cx="4066851" cy="33981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F6ACA3F-7CFF-4DE8-A90A-F501A546C422}"/>
              </a:ext>
            </a:extLst>
          </p:cNvPr>
          <p:cNvSpPr txBox="1"/>
          <p:nvPr/>
        </p:nvSpPr>
        <p:spPr>
          <a:xfrm>
            <a:off x="8106033" y="2905780"/>
            <a:ext cx="13963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. Mass vaccination sites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00000000-0008-0000-0200-00001B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54" y="3398108"/>
            <a:ext cx="4059114" cy="34172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064F29C-F54D-4146-9CD0-8F6ABB26C6DC}"/>
              </a:ext>
            </a:extLst>
          </p:cNvPr>
          <p:cNvSpPr txBox="1"/>
          <p:nvPr/>
        </p:nvSpPr>
        <p:spPr>
          <a:xfrm>
            <a:off x="185351" y="6340818"/>
            <a:ext cx="1227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. Pharmacy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00000000-0008-0000-0200-00001C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4203" y="3398108"/>
            <a:ext cx="3989749" cy="34172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9071FC2C-1964-4A60-AFB4-2F36668100FF}"/>
              </a:ext>
            </a:extLst>
          </p:cNvPr>
          <p:cNvSpPr txBox="1"/>
          <p:nvPr/>
        </p:nvSpPr>
        <p:spPr>
          <a:xfrm>
            <a:off x="4131274" y="6352291"/>
            <a:ext cx="119036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E. Physician office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00000000-0008-0000-0200-00001D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92188" y="3380837"/>
            <a:ext cx="4042146" cy="34172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C24F517F-BAF9-4CFC-8749-97EEBED5F48D}"/>
              </a:ext>
            </a:extLst>
          </p:cNvPr>
          <p:cNvSpPr txBox="1"/>
          <p:nvPr/>
        </p:nvSpPr>
        <p:spPr>
          <a:xfrm>
            <a:off x="8151339" y="6460012"/>
            <a:ext cx="1190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. Other</a:t>
            </a:r>
          </a:p>
        </p:txBody>
      </p:sp>
    </p:spTree>
    <p:extLst>
      <p:ext uri="{BB962C8B-B14F-4D97-AF65-F5344CB8AC3E}">
        <p14:creationId xmlns:p14="http://schemas.microsoft.com/office/powerpoint/2010/main" val="392281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, Cherry</dc:creator>
  <cp:lastModifiedBy>Chu, Cherry</cp:lastModifiedBy>
  <cp:revision>1</cp:revision>
  <dcterms:created xsi:type="dcterms:W3CDTF">2022-08-22T19:07:13Z</dcterms:created>
  <dcterms:modified xsi:type="dcterms:W3CDTF">2022-08-22T19:07:54Z</dcterms:modified>
</cp:coreProperties>
</file>